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11"/>
  </p:notesMasterIdLst>
  <p:sldIdLst>
    <p:sldId id="273" r:id="rId5"/>
    <p:sldId id="277" r:id="rId6"/>
    <p:sldId id="278" r:id="rId7"/>
    <p:sldId id="269" r:id="rId8"/>
    <p:sldId id="279" r:id="rId9"/>
    <p:sldId id="267" r:id="rId10"/>
  </p:sldIdLst>
  <p:sldSz cx="12192000" cy="12801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0099"/>
    <a:srgbClr val="00FF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857" autoAdjust="0"/>
    <p:restoredTop sz="94660"/>
  </p:normalViewPr>
  <p:slideViewPr>
    <p:cSldViewPr snapToGrid="0">
      <p:cViewPr varScale="1">
        <p:scale>
          <a:sx n="64" d="100"/>
          <a:sy n="64" d="100"/>
        </p:scale>
        <p:origin x="240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uan, Lijuan" userId="fa702c95-d82b-4a90-95b3-32669fe1e5f7" providerId="ADAL" clId="{653C5F94-E5FF-43EB-9B32-787A142C9A9F}"/>
    <pc:docChg chg="modSld sldOrd">
      <pc:chgData name="Yuan, Lijuan" userId="fa702c95-d82b-4a90-95b3-32669fe1e5f7" providerId="ADAL" clId="{653C5F94-E5FF-43EB-9B32-787A142C9A9F}" dt="2023-08-29T20:18:23.627" v="9" actId="20577"/>
      <pc:docMkLst>
        <pc:docMk/>
      </pc:docMkLst>
      <pc:sldChg chg="modSp">
        <pc:chgData name="Yuan, Lijuan" userId="fa702c95-d82b-4a90-95b3-32669fe1e5f7" providerId="ADAL" clId="{653C5F94-E5FF-43EB-9B32-787A142C9A9F}" dt="2023-08-29T20:18:15.617" v="6" actId="20577"/>
        <pc:sldMkLst>
          <pc:docMk/>
          <pc:sldMk cId="2890028149" sldId="267"/>
        </pc:sldMkLst>
        <pc:spChg chg="mod">
          <ac:chgData name="Yuan, Lijuan" userId="fa702c95-d82b-4a90-95b3-32669fe1e5f7" providerId="ADAL" clId="{653C5F94-E5FF-43EB-9B32-787A142C9A9F}" dt="2023-08-29T20:18:15.617" v="6" actId="20577"/>
          <ac:spMkLst>
            <pc:docMk/>
            <pc:sldMk cId="2890028149" sldId="267"/>
            <ac:spMk id="21" creationId="{2F492F59-EEF5-4083-A584-742F62F51AD2}"/>
          </ac:spMkLst>
        </pc:spChg>
      </pc:sldChg>
      <pc:sldChg chg="modSp ord">
        <pc:chgData name="Yuan, Lijuan" userId="fa702c95-d82b-4a90-95b3-32669fe1e5f7" providerId="ADAL" clId="{653C5F94-E5FF-43EB-9B32-787A142C9A9F}" dt="2023-08-29T20:18:23.627" v="9" actId="20577"/>
        <pc:sldMkLst>
          <pc:docMk/>
          <pc:sldMk cId="2496258528" sldId="279"/>
        </pc:sldMkLst>
        <pc:spChg chg="mod">
          <ac:chgData name="Yuan, Lijuan" userId="fa702c95-d82b-4a90-95b3-32669fe1e5f7" providerId="ADAL" clId="{653C5F94-E5FF-43EB-9B32-787A142C9A9F}" dt="2023-08-29T20:18:23.627" v="9" actId="20577"/>
          <ac:spMkLst>
            <pc:docMk/>
            <pc:sldMk cId="2496258528" sldId="279"/>
            <ac:spMk id="2" creationId="{CCE23FDE-4EC0-4AAD-86C4-35E42570D54E}"/>
          </ac:spMkLst>
        </pc:spChg>
        <pc:spChg chg="mod">
          <ac:chgData name="Yuan, Lijuan" userId="fa702c95-d82b-4a90-95b3-32669fe1e5f7" providerId="ADAL" clId="{653C5F94-E5FF-43EB-9B32-787A142C9A9F}" dt="2023-08-29T20:16:58.191" v="4" actId="14100"/>
          <ac:spMkLst>
            <pc:docMk/>
            <pc:sldMk cId="2496258528" sldId="279"/>
            <ac:spMk id="3" creationId="{631BDC28-5C25-429D-899C-23192A6B1710}"/>
          </ac:spMkLst>
        </pc:spChg>
        <pc:spChg chg="mod">
          <ac:chgData name="Yuan, Lijuan" userId="fa702c95-d82b-4a90-95b3-32669fe1e5f7" providerId="ADAL" clId="{653C5F94-E5FF-43EB-9B32-787A142C9A9F}" dt="2023-08-29T20:16:40.575" v="3" actId="14100"/>
          <ac:spMkLst>
            <pc:docMk/>
            <pc:sldMk cId="2496258528" sldId="279"/>
            <ac:spMk id="6" creationId="{D13DCDA1-207F-4A16-B0CE-B5B2F2DC38E2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088C27E-F082-47A3-9DEC-686CA969BF1D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58975" y="1143000"/>
            <a:ext cx="29400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F05B23-1C4C-4A1B-B672-597AC4D5F9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93842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095078"/>
            <a:ext cx="10363200" cy="4456853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6723804"/>
            <a:ext cx="9144000" cy="3090756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C6B78A-8139-4199-80B5-B8FB5A5469A2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4988F-DBF5-435F-B90A-069F6BC05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9630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C6B78A-8139-4199-80B5-B8FB5A5469A2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4988F-DBF5-435F-B90A-069F6BC05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9549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681567"/>
            <a:ext cx="2628900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681567"/>
            <a:ext cx="7734300" cy="10848764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C6B78A-8139-4199-80B5-B8FB5A5469A2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4988F-DBF5-435F-B90A-069F6BC05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5606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C6B78A-8139-4199-80B5-B8FB5A5469A2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4988F-DBF5-435F-B90A-069F6BC05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6045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191514"/>
            <a:ext cx="10515600" cy="532510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8567000"/>
            <a:ext cx="10515600" cy="28003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C6B78A-8139-4199-80B5-B8FB5A5469A2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4988F-DBF5-435F-B90A-069F6BC05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69500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407833"/>
            <a:ext cx="5181600" cy="812249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407833"/>
            <a:ext cx="5181600" cy="812249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C6B78A-8139-4199-80B5-B8FB5A5469A2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4988F-DBF5-435F-B90A-069F6BC05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54465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81570"/>
            <a:ext cx="10515600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138171"/>
            <a:ext cx="5157787" cy="153796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4676140"/>
            <a:ext cx="5157787" cy="687789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138171"/>
            <a:ext cx="5183188" cy="153796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4676140"/>
            <a:ext cx="5183188" cy="687789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C6B78A-8139-4199-80B5-B8FB5A5469A2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4988F-DBF5-435F-B90A-069F6BC05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67327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C6B78A-8139-4199-80B5-B8FB5A5469A2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4988F-DBF5-435F-B90A-069F6BC05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21457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C6B78A-8139-4199-80B5-B8FB5A5469A2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4988F-DBF5-435F-B90A-069F6BC05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22567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53440"/>
            <a:ext cx="3932237" cy="298704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843196"/>
            <a:ext cx="6172200" cy="9097433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840480"/>
            <a:ext cx="3932237" cy="7114964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C6B78A-8139-4199-80B5-B8FB5A5469A2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4988F-DBF5-435F-B90A-069F6BC05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96436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53440"/>
            <a:ext cx="3932237" cy="298704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843196"/>
            <a:ext cx="6172200" cy="9097433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840480"/>
            <a:ext cx="3932237" cy="7114964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C6B78A-8139-4199-80B5-B8FB5A5469A2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64988F-DBF5-435F-B90A-069F6BC05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804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681570"/>
            <a:ext cx="10515600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407833"/>
            <a:ext cx="10515600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1865189"/>
            <a:ext cx="274320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C6B78A-8139-4199-80B5-B8FB5A5469A2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1865189"/>
            <a:ext cx="411480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1865189"/>
            <a:ext cx="274320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64988F-DBF5-435F-B90A-069F6BC05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14814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g"/><Relationship Id="rId13" Type="http://schemas.openxmlformats.org/officeDocument/2006/relationships/image" Target="../media/image13.jpg"/><Relationship Id="rId3" Type="http://schemas.openxmlformats.org/officeDocument/2006/relationships/image" Target="../media/image3.jpg"/><Relationship Id="rId7" Type="http://schemas.openxmlformats.org/officeDocument/2006/relationships/image" Target="../media/image7.jpg"/><Relationship Id="rId12" Type="http://schemas.openxmlformats.org/officeDocument/2006/relationships/image" Target="../media/image12.jp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jpg"/><Relationship Id="rId11" Type="http://schemas.openxmlformats.org/officeDocument/2006/relationships/image" Target="../media/image11.jpg"/><Relationship Id="rId5" Type="http://schemas.openxmlformats.org/officeDocument/2006/relationships/image" Target="../media/image5.jpg"/><Relationship Id="rId10" Type="http://schemas.openxmlformats.org/officeDocument/2006/relationships/image" Target="../media/image10.jpg"/><Relationship Id="rId4" Type="http://schemas.openxmlformats.org/officeDocument/2006/relationships/image" Target="../media/image4.jpg"/><Relationship Id="rId9" Type="http://schemas.openxmlformats.org/officeDocument/2006/relationships/image" Target="../media/image9.jp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3" Type="http://schemas.openxmlformats.org/officeDocument/2006/relationships/image" Target="../media/image15.png"/><Relationship Id="rId7" Type="http://schemas.openxmlformats.org/officeDocument/2006/relationships/image" Target="../media/image19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Relationship Id="rId9" Type="http://schemas.openxmlformats.org/officeDocument/2006/relationships/image" Target="../media/image21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jpg"/><Relationship Id="rId13" Type="http://schemas.openxmlformats.org/officeDocument/2006/relationships/image" Target="../media/image33.jpg"/><Relationship Id="rId3" Type="http://schemas.openxmlformats.org/officeDocument/2006/relationships/image" Target="../media/image23.jpg"/><Relationship Id="rId7" Type="http://schemas.openxmlformats.org/officeDocument/2006/relationships/image" Target="../media/image27.jpg"/><Relationship Id="rId12" Type="http://schemas.openxmlformats.org/officeDocument/2006/relationships/image" Target="../media/image32.jpg"/><Relationship Id="rId2" Type="http://schemas.openxmlformats.org/officeDocument/2006/relationships/image" Target="../media/image22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jpg"/><Relationship Id="rId11" Type="http://schemas.openxmlformats.org/officeDocument/2006/relationships/image" Target="../media/image31.jpg"/><Relationship Id="rId5" Type="http://schemas.openxmlformats.org/officeDocument/2006/relationships/image" Target="../media/image25.jpg"/><Relationship Id="rId10" Type="http://schemas.openxmlformats.org/officeDocument/2006/relationships/image" Target="../media/image30.jpg"/><Relationship Id="rId4" Type="http://schemas.openxmlformats.org/officeDocument/2006/relationships/image" Target="../media/image24.jpg"/><Relationship Id="rId9" Type="http://schemas.openxmlformats.org/officeDocument/2006/relationships/image" Target="../media/image29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CB80D31-177D-48D0-A138-EADEB63079BD}"/>
              </a:ext>
            </a:extLst>
          </p:cNvPr>
          <p:cNvSpPr txBox="1"/>
          <p:nvPr/>
        </p:nvSpPr>
        <p:spPr>
          <a:xfrm>
            <a:off x="919843" y="5868708"/>
            <a:ext cx="10352314" cy="13250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able S1. 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Division of Gn pigs. A total of 26 pigs were used for these experiments. Diluent #5 was used as a mock infection control. </a:t>
            </a:r>
            <a:r>
              <a:rPr lang="en-US" sz="14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rRotarix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: recombinant Rotarix; </a:t>
            </a: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rRRV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: recombinant rhesus rotavirus; Wa </a:t>
            </a:r>
            <a:r>
              <a:rPr lang="en-US" sz="14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AttHRV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: attenuated Wa strain of HRV; SIC: small intestinal contents; LIC: large intestinal contents. </a:t>
            </a:r>
            <a:endParaRPr lang="en-US" sz="14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0F6E6C82-B595-4CCF-8561-0433ADA466D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39324845"/>
              </p:ext>
            </p:extLst>
          </p:nvPr>
        </p:nvGraphicFramePr>
        <p:xfrm>
          <a:off x="1220804" y="325946"/>
          <a:ext cx="9224167" cy="5237480"/>
        </p:xfrm>
        <a:graphic>
          <a:graphicData uri="http://schemas.openxmlformats.org/drawingml/2006/table">
            <a:tbl>
              <a:tblPr firstRow="1" bandRow="1"/>
              <a:tblGrid>
                <a:gridCol w="2631885">
                  <a:extLst>
                    <a:ext uri="{9D8B030D-6E8A-4147-A177-3AD203B41FA5}">
                      <a16:colId xmlns:a16="http://schemas.microsoft.com/office/drawing/2014/main" val="360505187"/>
                    </a:ext>
                  </a:extLst>
                </a:gridCol>
                <a:gridCol w="836270">
                  <a:extLst>
                    <a:ext uri="{9D8B030D-6E8A-4147-A177-3AD203B41FA5}">
                      <a16:colId xmlns:a16="http://schemas.microsoft.com/office/drawing/2014/main" val="3369367561"/>
                    </a:ext>
                  </a:extLst>
                </a:gridCol>
                <a:gridCol w="1634715">
                  <a:extLst>
                    <a:ext uri="{9D8B030D-6E8A-4147-A177-3AD203B41FA5}">
                      <a16:colId xmlns:a16="http://schemas.microsoft.com/office/drawing/2014/main" val="3835977477"/>
                    </a:ext>
                  </a:extLst>
                </a:gridCol>
                <a:gridCol w="4121297">
                  <a:extLst>
                    <a:ext uri="{9D8B030D-6E8A-4147-A177-3AD203B41FA5}">
                      <a16:colId xmlns:a16="http://schemas.microsoft.com/office/drawing/2014/main" val="3729505576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uthanasia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s Collected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901608572"/>
                  </a:ext>
                </a:extLst>
              </a:tr>
              <a:tr h="370840">
                <a:tc rowSpan="2"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tarix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D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livary glands, ileum, nasal tissue, fecal and nasal swab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241514944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D1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C, LIC, serum, fecal and nasal swab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27930163"/>
                  </a:ext>
                </a:extLst>
              </a:tr>
              <a:tr h="370840">
                <a:tc rowSpan="2">
                  <a:txBody>
                    <a:bodyPr/>
                    <a:lstStyle/>
                    <a:p>
                      <a:pPr algn="ctr"/>
                      <a:r>
                        <a:rPr lang="en-US" sz="16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RV</a:t>
                      </a:r>
                      <a:endParaRPr 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D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livary glands, ileum, nasal tissue, fecal and nasal swabs</a:t>
                      </a:r>
                    </a:p>
                    <a:p>
                      <a:pPr algn="ctr"/>
                      <a:endParaRPr 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999859607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D1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C, LIC, serum, fecal and nasal swab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885966273"/>
                  </a:ext>
                </a:extLst>
              </a:tr>
              <a:tr h="370840">
                <a:tc rowSpan="2"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a </a:t>
                      </a:r>
                      <a:r>
                        <a:rPr lang="en-US" sz="16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tHRV</a:t>
                      </a:r>
                      <a:endParaRPr lang="en-US" sz="16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D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livary glands, ileum, nasal tissue, fecal and nasal swabs</a:t>
                      </a:r>
                    </a:p>
                    <a:p>
                      <a:pPr algn="ctr"/>
                      <a:endParaRPr 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826456476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D1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C, LIC, serum, fecal and nasal swab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10987664"/>
                  </a:ext>
                </a:extLst>
              </a:tr>
              <a:tr h="370840">
                <a:tc rowSpan="2"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luen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D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livary glands, ileum, nasal tissue, fecal and nasal swabs</a:t>
                      </a:r>
                    </a:p>
                    <a:p>
                      <a:pPr algn="ctr"/>
                      <a:endParaRPr 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1137450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D1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C, LIC, serum, fecal and nasal swab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207916692"/>
                  </a:ext>
                </a:extLst>
              </a:tr>
              <a:tr h="248755">
                <a:tc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RVs</a:t>
                      </a:r>
                      <a:endParaRPr 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D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livary glands, saliva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07845839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164713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0A0A5759-44CE-41B6-BAAC-96F0937E59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33655802"/>
              </p:ext>
            </p:extLst>
          </p:nvPr>
        </p:nvGraphicFramePr>
        <p:xfrm>
          <a:off x="683566" y="1051278"/>
          <a:ext cx="10824867" cy="7716357"/>
        </p:xfrm>
        <a:graphic>
          <a:graphicData uri="http://schemas.openxmlformats.org/drawingml/2006/table">
            <a:tbl>
              <a:tblPr firstRow="1" bandRow="1"/>
              <a:tblGrid>
                <a:gridCol w="785736">
                  <a:extLst>
                    <a:ext uri="{9D8B030D-6E8A-4147-A177-3AD203B41FA5}">
                      <a16:colId xmlns:a16="http://schemas.microsoft.com/office/drawing/2014/main" val="1928494342"/>
                    </a:ext>
                  </a:extLst>
                </a:gridCol>
                <a:gridCol w="770625">
                  <a:extLst>
                    <a:ext uri="{9D8B030D-6E8A-4147-A177-3AD203B41FA5}">
                      <a16:colId xmlns:a16="http://schemas.microsoft.com/office/drawing/2014/main" val="3735086996"/>
                    </a:ext>
                  </a:extLst>
                </a:gridCol>
                <a:gridCol w="968739">
                  <a:extLst>
                    <a:ext uri="{9D8B030D-6E8A-4147-A177-3AD203B41FA5}">
                      <a16:colId xmlns:a16="http://schemas.microsoft.com/office/drawing/2014/main" val="2403996339"/>
                    </a:ext>
                  </a:extLst>
                </a:gridCol>
                <a:gridCol w="754912">
                  <a:extLst>
                    <a:ext uri="{9D8B030D-6E8A-4147-A177-3AD203B41FA5}">
                      <a16:colId xmlns:a16="http://schemas.microsoft.com/office/drawing/2014/main" val="2274459507"/>
                    </a:ext>
                  </a:extLst>
                </a:gridCol>
                <a:gridCol w="781591">
                  <a:extLst>
                    <a:ext uri="{9D8B030D-6E8A-4147-A177-3AD203B41FA5}">
                      <a16:colId xmlns:a16="http://schemas.microsoft.com/office/drawing/2014/main" val="1545143932"/>
                    </a:ext>
                  </a:extLst>
                </a:gridCol>
                <a:gridCol w="845190">
                  <a:extLst>
                    <a:ext uri="{9D8B030D-6E8A-4147-A177-3AD203B41FA5}">
                      <a16:colId xmlns:a16="http://schemas.microsoft.com/office/drawing/2014/main" val="3271170898"/>
                    </a:ext>
                  </a:extLst>
                </a:gridCol>
                <a:gridCol w="903768">
                  <a:extLst>
                    <a:ext uri="{9D8B030D-6E8A-4147-A177-3AD203B41FA5}">
                      <a16:colId xmlns:a16="http://schemas.microsoft.com/office/drawing/2014/main" val="2387661878"/>
                    </a:ext>
                  </a:extLst>
                </a:gridCol>
                <a:gridCol w="808074">
                  <a:extLst>
                    <a:ext uri="{9D8B030D-6E8A-4147-A177-3AD203B41FA5}">
                      <a16:colId xmlns:a16="http://schemas.microsoft.com/office/drawing/2014/main" val="2312348371"/>
                    </a:ext>
                  </a:extLst>
                </a:gridCol>
                <a:gridCol w="946298">
                  <a:extLst>
                    <a:ext uri="{9D8B030D-6E8A-4147-A177-3AD203B41FA5}">
                      <a16:colId xmlns:a16="http://schemas.microsoft.com/office/drawing/2014/main" val="4118507379"/>
                    </a:ext>
                  </a:extLst>
                </a:gridCol>
                <a:gridCol w="946298">
                  <a:extLst>
                    <a:ext uri="{9D8B030D-6E8A-4147-A177-3AD203B41FA5}">
                      <a16:colId xmlns:a16="http://schemas.microsoft.com/office/drawing/2014/main" val="176755619"/>
                    </a:ext>
                  </a:extLst>
                </a:gridCol>
                <a:gridCol w="1137683">
                  <a:extLst>
                    <a:ext uri="{9D8B030D-6E8A-4147-A177-3AD203B41FA5}">
                      <a16:colId xmlns:a16="http://schemas.microsoft.com/office/drawing/2014/main" val="3827319446"/>
                    </a:ext>
                  </a:extLst>
                </a:gridCol>
                <a:gridCol w="1175953">
                  <a:extLst>
                    <a:ext uri="{9D8B030D-6E8A-4147-A177-3AD203B41FA5}">
                      <a16:colId xmlns:a16="http://schemas.microsoft.com/office/drawing/2014/main" val="3802065096"/>
                    </a:ext>
                  </a:extLst>
                </a:gridCol>
              </a:tblGrid>
              <a:tr h="353140">
                <a:tc>
                  <a:txBody>
                    <a:bodyPr/>
                    <a:lstStyle/>
                    <a:p>
                      <a:pPr algn="ctr"/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g I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uthanasia Dat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sal Virus Shedding by RT-qPCR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sal Virus  Shedding by ELISPO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cal Virus Shedding by</a:t>
                      </a:r>
                    </a:p>
                    <a:p>
                      <a:pPr algn="ctr"/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T-qPCR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cal Virus Shedding by</a:t>
                      </a:r>
                    </a:p>
                    <a:p>
                      <a:pPr algn="ctr"/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LISPO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P6 Antigen in Nasal Cavit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P6 Antigen in Salivary Gland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P6 Antigen in Ileum</a:t>
                      </a:r>
                      <a:endParaRPr lang="en-US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V Genomes in Ileum</a:t>
                      </a:r>
                      <a:endParaRPr lang="en-US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5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RV Genomes in Salivary Tissue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65449696"/>
                  </a:ext>
                </a:extLst>
              </a:tr>
              <a:tr h="232202">
                <a:tc rowSpan="5">
                  <a:txBody>
                    <a:bodyPr/>
                    <a:lstStyle/>
                    <a:p>
                      <a:pPr algn="ctr"/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tarix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6-1-22</a:t>
                      </a: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D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sz="105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5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sz="105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5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5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672707623"/>
                  </a:ext>
                </a:extLst>
              </a:tr>
              <a:tr h="384251">
                <a:tc vMerge="1"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6-2-22</a:t>
                      </a: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US" sz="16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57778777"/>
                  </a:ext>
                </a:extLst>
              </a:tr>
              <a:tr h="232202">
                <a:tc vMerge="1"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6-3-22</a:t>
                      </a:r>
                    </a:p>
                  </a:txBody>
                  <a:tcPr anchor="ctr"/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D1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 rowSpan="3" gridSpan="5"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anchor="ctr"/>
                </a:tc>
                <a:tc rowSpan="3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3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3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3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07652546"/>
                  </a:ext>
                </a:extLst>
              </a:tr>
              <a:tr h="232202">
                <a:tc vMerge="1"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6-4-22</a:t>
                      </a: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US" sz="16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BR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 gridSpan="5" vMerge="1">
                  <a:txBody>
                    <a:bodyPr/>
                    <a:lstStyle/>
                    <a:p>
                      <a:pPr algn="ctr"/>
                      <a:endParaRPr lang="en-US" sz="16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70354810"/>
                  </a:ext>
                </a:extLst>
              </a:tr>
              <a:tr h="353140">
                <a:tc vMerge="1"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50" b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6-5-22</a:t>
                      </a: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de-DE" sz="16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 gridSpan="5" vMerge="1">
                  <a:txBody>
                    <a:bodyPr/>
                    <a:lstStyle/>
                    <a:p>
                      <a:pPr algn="ctr"/>
                      <a:endParaRPr lang="en-US" sz="16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28834069"/>
                  </a:ext>
                </a:extLst>
              </a:tr>
              <a:tr h="353140">
                <a:tc rowSpan="6"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RV</a:t>
                      </a:r>
                      <a:endParaRPr lang="en-US" sz="105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50" b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6-6-22</a:t>
                      </a: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de-DE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D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sz="105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sz="105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sz="105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105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91437787"/>
                  </a:ext>
                </a:extLst>
              </a:tr>
              <a:tr h="353140">
                <a:tc vMerge="1">
                  <a:txBody>
                    <a:bodyPr/>
                    <a:lstStyle/>
                    <a:p>
                      <a:pPr algn="l"/>
                      <a:endParaRPr 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50" b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6-7-22</a:t>
                      </a: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l"/>
                      <a:endParaRPr lang="de-DE" sz="16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83912388"/>
                  </a:ext>
                </a:extLst>
              </a:tr>
              <a:tr h="353140">
                <a:tc vMerge="1">
                  <a:txBody>
                    <a:bodyPr/>
                    <a:lstStyle/>
                    <a:p>
                      <a:pPr algn="l"/>
                      <a:endParaRPr 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50" b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6-8-22</a:t>
                      </a:r>
                    </a:p>
                  </a:txBody>
                  <a:tcPr anchor="ctr"/>
                </a:tc>
                <a:tc rowSpan="4">
                  <a:txBody>
                    <a:bodyPr/>
                    <a:lstStyle/>
                    <a:p>
                      <a:pPr algn="ctr"/>
                      <a:r>
                        <a:rPr lang="de-DE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D1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 rowSpan="4" gridSpan="5"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anchor="ctr"/>
                </a:tc>
                <a:tc rowSpan="4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77365608"/>
                  </a:ext>
                </a:extLst>
              </a:tr>
              <a:tr h="353140">
                <a:tc vMerge="1">
                  <a:txBody>
                    <a:bodyPr/>
                    <a:lstStyle/>
                    <a:p>
                      <a:pPr algn="l"/>
                      <a:endParaRPr 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50" b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6-9-22</a:t>
                      </a: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l"/>
                      <a:endParaRPr lang="de-DE" sz="16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 gridSpan="5" vMerge="1">
                  <a:txBody>
                    <a:bodyPr/>
                    <a:lstStyle/>
                    <a:p>
                      <a:pPr algn="ctr"/>
                      <a:endParaRPr lang="en-US" sz="16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35642305"/>
                  </a:ext>
                </a:extLst>
              </a:tr>
              <a:tr h="353140">
                <a:tc vMerge="1">
                  <a:txBody>
                    <a:bodyPr/>
                    <a:lstStyle/>
                    <a:p>
                      <a:pPr algn="l"/>
                      <a:endParaRPr 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50" b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6-10-22</a:t>
                      </a: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l"/>
                      <a:endParaRPr lang="de-DE" sz="16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 gridSpan="5" vMerge="1">
                  <a:txBody>
                    <a:bodyPr/>
                    <a:lstStyle/>
                    <a:p>
                      <a:pPr algn="ctr"/>
                      <a:endParaRPr lang="en-US" sz="16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78004562"/>
                  </a:ext>
                </a:extLst>
              </a:tr>
              <a:tr h="353140">
                <a:tc vMerge="1">
                  <a:txBody>
                    <a:bodyPr/>
                    <a:lstStyle/>
                    <a:p>
                      <a:pPr algn="l"/>
                      <a:endParaRPr 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50" b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6-11-22</a:t>
                      </a: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l"/>
                      <a:endParaRPr lang="de-DE" sz="16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 gridSpan="5" vMerge="1">
                  <a:txBody>
                    <a:bodyPr/>
                    <a:lstStyle/>
                    <a:p>
                      <a:pPr algn="ctr"/>
                      <a:endParaRPr lang="en-US" sz="16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47332428"/>
                  </a:ext>
                </a:extLst>
              </a:tr>
              <a:tr h="353140">
                <a:tc rowSpan="6"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a</a:t>
                      </a:r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5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tHRV</a:t>
                      </a:r>
                      <a:endParaRPr lang="en-US" sz="105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50" b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7-1-22</a:t>
                      </a:r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de-DE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D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sz="105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sz="105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sz="105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105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675636330"/>
                  </a:ext>
                </a:extLst>
              </a:tr>
              <a:tr h="353140">
                <a:tc vMerge="1"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50" b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7-2-22</a:t>
                      </a: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de-DE" sz="16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97217431"/>
                  </a:ext>
                </a:extLst>
              </a:tr>
              <a:tr h="353140">
                <a:tc vMerge="1"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50" b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7-3-22</a:t>
                      </a:r>
                    </a:p>
                  </a:txBody>
                  <a:tcPr anchor="ctr"/>
                </a:tc>
                <a:tc rowSpan="4">
                  <a:txBody>
                    <a:bodyPr/>
                    <a:lstStyle/>
                    <a:p>
                      <a:pPr algn="ctr"/>
                      <a:r>
                        <a:rPr lang="de-DE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D1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 rowSpan="4" gridSpan="5"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anchor="ctr"/>
                </a:tc>
                <a:tc rowSpan="4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16904554"/>
                  </a:ext>
                </a:extLst>
              </a:tr>
              <a:tr h="353140">
                <a:tc vMerge="1"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7-4-22</a:t>
                      </a: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l"/>
                      <a:endParaRPr lang="en-US" sz="16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 gridSpan="5" vMerge="1">
                  <a:txBody>
                    <a:bodyPr/>
                    <a:lstStyle/>
                    <a:p>
                      <a:pPr algn="ctr"/>
                      <a:endParaRPr lang="en-US" sz="16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54636477"/>
                  </a:ext>
                </a:extLst>
              </a:tr>
              <a:tr h="353140">
                <a:tc vMerge="1"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7-5-22</a:t>
                      </a: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l"/>
                      <a:endParaRPr lang="en-US" sz="1600" b="1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 gridSpan="5" vMerge="1">
                  <a:txBody>
                    <a:bodyPr/>
                    <a:lstStyle/>
                    <a:p>
                      <a:pPr algn="ctr"/>
                      <a:endParaRPr lang="en-US" sz="1600" dirty="0"/>
                    </a:p>
                  </a:txBody>
                  <a:tcPr anchor="ctr"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3218647"/>
                  </a:ext>
                </a:extLst>
              </a:tr>
              <a:tr h="389086">
                <a:tc vMerge="1"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50" b="0" baseline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p7-6-22</a:t>
                      </a:r>
                    </a:p>
                  </a:txBody>
                  <a:tcPr marL="7620" marR="7620" marT="7620" marB="0" anchor="ctr"/>
                </a:tc>
                <a:tc vMerge="1"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US" sz="1600" baseline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50" baseline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50" baseline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50" baseline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50" baseline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7620" marR="7620" marT="7620" marB="0" anchor="ctr"/>
                </a:tc>
                <a:tc gridSpan="5" vMerge="1"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US" sz="1600" baseline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30371874"/>
                  </a:ext>
                </a:extLst>
              </a:tr>
              <a:tr h="353140">
                <a:tc rowSpan="3">
                  <a:txBody>
                    <a:bodyPr/>
                    <a:lstStyle/>
                    <a:p>
                      <a:pPr marL="0" marR="0" lvl="0" indent="0" algn="ctr" defTabSz="121917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luen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50" b="0" baseline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p7-7-22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50" baseline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ID2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50" baseline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50" baseline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50" baseline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50" baseline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50" baseline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50" baseline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50" baseline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50" baseline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50" baseline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980995282"/>
                  </a:ext>
                </a:extLst>
              </a:tr>
              <a:tr h="353140">
                <a:tc vMerge="1"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50" b="0" baseline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p7-8-22</a:t>
                      </a:r>
                    </a:p>
                  </a:txBody>
                  <a:tcPr marL="7620" marR="7620" marT="7620" marB="0" anchor="ctr"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50" baseline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ID1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50" baseline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50" baseline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50" baseline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50" baseline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7620" marR="7620" marT="7620" marB="0" anchor="ctr"/>
                </a:tc>
                <a:tc rowSpan="2" gridSpan="5"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50" baseline="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7620" marR="7620" marT="7620" marB="0" anchor="ctr"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3857000"/>
                  </a:ext>
                </a:extLst>
              </a:tr>
              <a:tr h="353140">
                <a:tc vMerge="1">
                  <a:txBody>
                    <a:bodyPr/>
                    <a:lstStyle/>
                    <a:p>
                      <a:pPr algn="ctr"/>
                      <a:endParaRPr 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7-9-22</a:t>
                      </a: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US" sz="16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anchor="ctr"/>
                </a:tc>
                <a:tc gridSpan="5" vMerge="1">
                  <a:txBody>
                    <a:bodyPr/>
                    <a:lstStyle/>
                    <a:p>
                      <a:pPr algn="ctr"/>
                      <a:endParaRPr lang="en-US" sz="16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0894418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0675F63D-3E97-40E1-89FA-C61C75CCCCA5}"/>
              </a:ext>
            </a:extLst>
          </p:cNvPr>
          <p:cNvSpPr txBox="1"/>
          <p:nvPr/>
        </p:nvSpPr>
        <p:spPr>
          <a:xfrm>
            <a:off x="-1" y="9469619"/>
            <a:ext cx="12192000" cy="13250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able S2. 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Detection of viral genomes (by RT-qPCR), infectious viral particles (by virus ELISPOT), and viral antigen (by immunofluorescent staining) in individual pigs infected with rotavirus strains of diluent. + indicates a positive sample at any time point and – indicates  a negative sample. NA: not applicable.</a:t>
            </a:r>
          </a:p>
        </p:txBody>
      </p:sp>
    </p:spTree>
    <p:extLst>
      <p:ext uri="{BB962C8B-B14F-4D97-AF65-F5344CB8AC3E}">
        <p14:creationId xmlns:p14="http://schemas.microsoft.com/office/powerpoint/2010/main" val="24138075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E7AEBDDE-8B2D-406C-A740-D5B37E464A8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48179568"/>
              </p:ext>
            </p:extLst>
          </p:nvPr>
        </p:nvGraphicFramePr>
        <p:xfrm>
          <a:off x="2783842" y="1377218"/>
          <a:ext cx="7457438" cy="67619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604238" imgH="3357800" progId="Prism10.Document">
                  <p:embed/>
                </p:oleObj>
              </mc:Choice>
              <mc:Fallback>
                <p:oleObj name="Prism 10" r:id="rId2" imgW="3604238" imgH="3357800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E7AEBDDE-8B2D-406C-A740-D5B37E464A8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783842" y="1377218"/>
                        <a:ext cx="7457438" cy="67619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951921A1-FD7F-43CE-8606-BED316FE1F7D}"/>
              </a:ext>
            </a:extLst>
          </p:cNvPr>
          <p:cNvSpPr txBox="1"/>
          <p:nvPr/>
        </p:nvSpPr>
        <p:spPr>
          <a:xfrm>
            <a:off x="2783842" y="8043413"/>
            <a:ext cx="7213598" cy="13250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1. 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Rotavirus genome detection in ileum and salivary gland tissue. Rotarix inoculated pigs: Gp6-1-22 and Gp6-2-22. </a:t>
            </a:r>
            <a:r>
              <a:rPr lang="en-US" sz="14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rRRV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inoculated pigs: Gp6-6-22 and Gp6-7-22. </a:t>
            </a:r>
            <a:r>
              <a:rPr lang="en-US" sz="14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Wa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attHRV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inoculated pigs: Gp7-1-22 and Gp7-2-22.  </a:t>
            </a: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endParaRPr lang="en-US" sz="14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59584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7">
            <a:extLst>
              <a:ext uri="{FF2B5EF4-FFF2-40B4-BE49-F238E27FC236}">
                <a16:creationId xmlns:a16="http://schemas.microsoft.com/office/drawing/2014/main" id="{FCE7F058-F243-448D-A97D-C1B2A7E4149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0777" y="3212588"/>
            <a:ext cx="1828800" cy="1828800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4E83FD2B-AB71-46A8-B234-6453055D3C3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7621" y="3224081"/>
            <a:ext cx="1828800" cy="1828800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3798C6AF-EC4F-4635-864B-97E1306EDA3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07273" y="3247102"/>
            <a:ext cx="1828800" cy="1828800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0DD0B3DD-9718-4969-B7F8-6DD94761FC5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65617" y="8345354"/>
            <a:ext cx="1828800" cy="1828800"/>
          </a:xfrm>
          <a:prstGeom prst="rect">
            <a:avLst/>
          </a:prstGeom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id="{F8BB1D51-C4B6-4A51-8EAD-064CF58A963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1149" y="8345354"/>
            <a:ext cx="1828800" cy="1828800"/>
          </a:xfrm>
          <a:prstGeom prst="rect">
            <a:avLst/>
          </a:prstGeom>
        </p:spPr>
      </p:pic>
      <p:pic>
        <p:nvPicPr>
          <p:cNvPr id="62" name="Picture 61">
            <a:extLst>
              <a:ext uri="{FF2B5EF4-FFF2-40B4-BE49-F238E27FC236}">
                <a16:creationId xmlns:a16="http://schemas.microsoft.com/office/drawing/2014/main" id="{97D15B49-A56D-437A-9D5B-26377BBDF8E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10276" y="8345354"/>
            <a:ext cx="1828800" cy="1828800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07227367-5D37-4BA3-9950-93AE14D5F4F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65617" y="5801506"/>
            <a:ext cx="1828800" cy="182880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EE475792-91B0-4956-A4E0-4AFE4BE3A14B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1149" y="5793002"/>
            <a:ext cx="1828800" cy="1828800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A00A1B94-BE82-4502-B5AF-66CEC5FFB5B9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53581" y="5793002"/>
            <a:ext cx="1828800" cy="18288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05E23D4-7EC7-4D9E-B09E-83E65C1A1419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53581" y="740711"/>
            <a:ext cx="1828800" cy="18288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0A56985A-9259-400A-A458-5FD2111B7F9B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3220" y="740711"/>
            <a:ext cx="1828800" cy="18288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57A8EE6-E2CA-46CE-9823-0B19B832E632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0777" y="740711"/>
            <a:ext cx="1828800" cy="1828800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95851048-F310-441D-B53E-99E9FEC80A4B}"/>
              </a:ext>
            </a:extLst>
          </p:cNvPr>
          <p:cNvSpPr txBox="1"/>
          <p:nvPr/>
        </p:nvSpPr>
        <p:spPr>
          <a:xfrm>
            <a:off x="2807752" y="263459"/>
            <a:ext cx="5826632" cy="4632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A. Parotid salivary gland of Rotarix inoculated Gn pig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A7763EE-3EC2-49CB-A9B8-01D76E8884B7}"/>
              </a:ext>
            </a:extLst>
          </p:cNvPr>
          <p:cNvSpPr txBox="1"/>
          <p:nvPr/>
        </p:nvSpPr>
        <p:spPr>
          <a:xfrm>
            <a:off x="2807752" y="2599346"/>
            <a:ext cx="6226191" cy="4632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B. Parotid salivary gland of Wa </a:t>
            </a:r>
            <a:r>
              <a:rPr lang="en-US" sz="1400" b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AttHRV</a:t>
            </a: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inoculated Gn pigs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438E7D0-2EE1-4723-8E90-909A723E9941}"/>
              </a:ext>
            </a:extLst>
          </p:cNvPr>
          <p:cNvSpPr txBox="1"/>
          <p:nvPr/>
        </p:nvSpPr>
        <p:spPr>
          <a:xfrm>
            <a:off x="2756190" y="5200167"/>
            <a:ext cx="6226191" cy="4786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. Parotid salivary gland of </a:t>
            </a:r>
            <a:r>
              <a:rPr lang="en-US" sz="1400" b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rRRV</a:t>
            </a: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inoculated Gn pig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F492F59-EEF5-4083-A584-742F62F51AD2}"/>
              </a:ext>
            </a:extLst>
          </p:cNvPr>
          <p:cNvSpPr txBox="1"/>
          <p:nvPr/>
        </p:nvSpPr>
        <p:spPr>
          <a:xfrm>
            <a:off x="2600961" y="10358087"/>
            <a:ext cx="7132319" cy="17559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2. 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Detection of rotavirus NSP3 antigen in the parotid salivary gland of Rotarix </a:t>
            </a: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(A)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Wa </a:t>
            </a:r>
            <a:r>
              <a:rPr lang="en-US" sz="14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AttHRV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(B)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</a:t>
            </a:r>
            <a:r>
              <a:rPr lang="en-US" sz="14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rRRV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(C)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or mock </a:t>
            </a: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(D)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inoculated pigs. Representative images from each group are shown. Images were taken using 25X objective on Zeiss LSM 880 confocal. Blue: DAPI. Green: rotavirus VP6. Scale bar is 160 pixels.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0FC70CB-ED96-439B-BEAA-D83A01454050}"/>
              </a:ext>
            </a:extLst>
          </p:cNvPr>
          <p:cNvSpPr txBox="1"/>
          <p:nvPr/>
        </p:nvSpPr>
        <p:spPr>
          <a:xfrm>
            <a:off x="2756190" y="7759387"/>
            <a:ext cx="6226192" cy="4632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D. Parotid salivary gland of mock inoculated Gn pigs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72DAEE1-358E-4862-A162-50C2A804780F}"/>
              </a:ext>
            </a:extLst>
          </p:cNvPr>
          <p:cNvSpPr txBox="1"/>
          <p:nvPr/>
        </p:nvSpPr>
        <p:spPr>
          <a:xfrm>
            <a:off x="2870777" y="682609"/>
            <a:ext cx="1399926" cy="5687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/</a:t>
            </a:r>
            <a:r>
              <a:rPr lang="en-US" b="1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SP3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4726713-0EF7-4609-BDDD-4A9742BCAB16}"/>
              </a:ext>
            </a:extLst>
          </p:cNvPr>
          <p:cNvSpPr txBox="1"/>
          <p:nvPr/>
        </p:nvSpPr>
        <p:spPr>
          <a:xfrm>
            <a:off x="5003220" y="682609"/>
            <a:ext cx="1177793" cy="5687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lang="en-US" b="1" dirty="0">
              <a:solidFill>
                <a:srgbClr val="00FF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05461C1-9A83-413F-8039-930C43052230}"/>
              </a:ext>
            </a:extLst>
          </p:cNvPr>
          <p:cNvSpPr txBox="1"/>
          <p:nvPr/>
        </p:nvSpPr>
        <p:spPr>
          <a:xfrm>
            <a:off x="7135663" y="682609"/>
            <a:ext cx="1177793" cy="5687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SP3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866FB65-5D89-4575-9A7C-F6C88D385319}"/>
              </a:ext>
            </a:extLst>
          </p:cNvPr>
          <p:cNvSpPr txBox="1"/>
          <p:nvPr/>
        </p:nvSpPr>
        <p:spPr>
          <a:xfrm>
            <a:off x="2870778" y="5763167"/>
            <a:ext cx="1568091" cy="5687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/</a:t>
            </a:r>
            <a:r>
              <a:rPr lang="en-US" b="1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SP3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639B9E4-F941-4AEC-B4E4-6785D14BD03F}"/>
              </a:ext>
            </a:extLst>
          </p:cNvPr>
          <p:cNvSpPr txBox="1"/>
          <p:nvPr/>
        </p:nvSpPr>
        <p:spPr>
          <a:xfrm>
            <a:off x="5003220" y="5763167"/>
            <a:ext cx="1177793" cy="5687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lang="en-US" b="1" dirty="0">
              <a:solidFill>
                <a:srgbClr val="00FF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C1828D0-0271-452A-ACB9-915BD7C8DC04}"/>
              </a:ext>
            </a:extLst>
          </p:cNvPr>
          <p:cNvSpPr txBox="1"/>
          <p:nvPr/>
        </p:nvSpPr>
        <p:spPr>
          <a:xfrm>
            <a:off x="7135663" y="5763167"/>
            <a:ext cx="1177793" cy="5687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SP3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1F80495-71B2-4D00-A477-158D77B295EA}"/>
              </a:ext>
            </a:extLst>
          </p:cNvPr>
          <p:cNvSpPr txBox="1"/>
          <p:nvPr/>
        </p:nvSpPr>
        <p:spPr>
          <a:xfrm>
            <a:off x="2870777" y="3173689"/>
            <a:ext cx="1399926" cy="5687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/</a:t>
            </a:r>
            <a:r>
              <a:rPr lang="en-US" b="1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SP3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01CD8A0-1F19-4FB0-AFAE-DF6F9CA6BFDE}"/>
              </a:ext>
            </a:extLst>
          </p:cNvPr>
          <p:cNvSpPr txBox="1"/>
          <p:nvPr/>
        </p:nvSpPr>
        <p:spPr>
          <a:xfrm>
            <a:off x="5003220" y="3173689"/>
            <a:ext cx="1177793" cy="5687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lang="en-US" b="1" dirty="0">
              <a:solidFill>
                <a:srgbClr val="00FF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E15EC54-903E-4F16-B711-4E859B0DF169}"/>
              </a:ext>
            </a:extLst>
          </p:cNvPr>
          <p:cNvSpPr txBox="1"/>
          <p:nvPr/>
        </p:nvSpPr>
        <p:spPr>
          <a:xfrm>
            <a:off x="7135663" y="3173689"/>
            <a:ext cx="1177793" cy="5687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SP3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2E1FEC1-CD69-4CA4-8A9C-2D1A0BBF3FF0}"/>
              </a:ext>
            </a:extLst>
          </p:cNvPr>
          <p:cNvSpPr txBox="1"/>
          <p:nvPr/>
        </p:nvSpPr>
        <p:spPr>
          <a:xfrm>
            <a:off x="2870779" y="8306738"/>
            <a:ext cx="1849025" cy="561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/</a:t>
            </a:r>
            <a:r>
              <a:rPr lang="en-US" b="1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SP3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535B34D-45A4-41FB-9AAC-DBC9B1B1B8D1}"/>
              </a:ext>
            </a:extLst>
          </p:cNvPr>
          <p:cNvSpPr txBox="1"/>
          <p:nvPr/>
        </p:nvSpPr>
        <p:spPr>
          <a:xfrm>
            <a:off x="5003220" y="8306738"/>
            <a:ext cx="1177793" cy="5687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lang="en-US" b="1" dirty="0">
              <a:solidFill>
                <a:srgbClr val="00FF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00B8346-BD87-4487-B4BB-371D9D5AC620}"/>
              </a:ext>
            </a:extLst>
          </p:cNvPr>
          <p:cNvSpPr txBox="1"/>
          <p:nvPr/>
        </p:nvSpPr>
        <p:spPr>
          <a:xfrm>
            <a:off x="7135663" y="8306738"/>
            <a:ext cx="1177793" cy="5687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SP3</a:t>
            </a:r>
          </a:p>
        </p:txBody>
      </p:sp>
    </p:spTree>
    <p:extLst>
      <p:ext uri="{BB962C8B-B14F-4D97-AF65-F5344CB8AC3E}">
        <p14:creationId xmlns:p14="http://schemas.microsoft.com/office/powerpoint/2010/main" val="24264567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CE23FDE-4EC0-4AAD-86C4-35E42570D54E}"/>
              </a:ext>
            </a:extLst>
          </p:cNvPr>
          <p:cNvSpPr txBox="1"/>
          <p:nvPr/>
        </p:nvSpPr>
        <p:spPr>
          <a:xfrm>
            <a:off x="2466462" y="10501356"/>
            <a:ext cx="7031757" cy="17559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3. </a:t>
            </a:r>
            <a:r>
              <a:rPr lang="en-US" sz="1400" dirty="0">
                <a:solidFill>
                  <a:prstClr val="black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Detection of rotavirus VP6 or NSP3 antigen in the parotid salivary gland of Rotarix </a:t>
            </a:r>
            <a:r>
              <a:rPr lang="en-US" sz="1400" b="1" dirty="0">
                <a:solidFill>
                  <a:prstClr val="black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(A)</a:t>
            </a:r>
            <a:r>
              <a:rPr lang="en-US" sz="1400" dirty="0">
                <a:solidFill>
                  <a:prstClr val="black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, </a:t>
            </a:r>
            <a:r>
              <a:rPr lang="en-US" sz="1400" dirty="0" err="1">
                <a:solidFill>
                  <a:prstClr val="black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Wa</a:t>
            </a:r>
            <a:r>
              <a:rPr lang="en-US" sz="1400" dirty="0">
                <a:solidFill>
                  <a:prstClr val="black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err="1">
                <a:solidFill>
                  <a:prstClr val="black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AttHRV</a:t>
            </a:r>
            <a:r>
              <a:rPr lang="en-US" sz="1400" dirty="0">
                <a:solidFill>
                  <a:prstClr val="black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solidFill>
                  <a:prstClr val="black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(B)</a:t>
            </a:r>
            <a:r>
              <a:rPr lang="en-US" sz="1400" dirty="0">
                <a:solidFill>
                  <a:prstClr val="black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, </a:t>
            </a:r>
            <a:r>
              <a:rPr lang="en-US" sz="1400" dirty="0" err="1">
                <a:solidFill>
                  <a:prstClr val="black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rRRV</a:t>
            </a:r>
            <a:r>
              <a:rPr lang="en-US" sz="1400" dirty="0">
                <a:solidFill>
                  <a:prstClr val="black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solidFill>
                  <a:prstClr val="black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(C)</a:t>
            </a:r>
            <a:r>
              <a:rPr lang="en-US" sz="1400" dirty="0">
                <a:solidFill>
                  <a:prstClr val="black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, or mock </a:t>
            </a:r>
            <a:r>
              <a:rPr lang="en-US" sz="1400" b="1" dirty="0">
                <a:solidFill>
                  <a:prstClr val="black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(D)</a:t>
            </a:r>
            <a:r>
              <a:rPr lang="en-US" sz="1400" dirty="0">
                <a:solidFill>
                  <a:prstClr val="black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 inoculated pigs. Images were taken at 10X on a </a:t>
            </a:r>
            <a:r>
              <a:rPr lang="en-US" sz="1400" dirty="0" err="1">
                <a:solidFill>
                  <a:prstClr val="black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BioRad</a:t>
            </a:r>
            <a:r>
              <a:rPr lang="en-US" sz="1400" dirty="0">
                <a:solidFill>
                  <a:prstClr val="black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err="1">
                <a:solidFill>
                  <a:prstClr val="black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Cytation</a:t>
            </a:r>
            <a:r>
              <a:rPr lang="en-US" sz="1400" dirty="0">
                <a:solidFill>
                  <a:prstClr val="black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 5. Blue: DAPI. Green: VP6 or NSP3. Scale bar is 300 µm.</a:t>
            </a:r>
            <a:endParaRPr lang="en-US" sz="14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31BDC28-5C25-429D-899C-23192A6B1710}"/>
              </a:ext>
            </a:extLst>
          </p:cNvPr>
          <p:cNvSpPr txBox="1"/>
          <p:nvPr/>
        </p:nvSpPr>
        <p:spPr>
          <a:xfrm>
            <a:off x="2668315" y="290073"/>
            <a:ext cx="4908142" cy="4632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A. Parotid salivary gland of Rotarix inoculated Gn pig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75BF310-45AF-4F2D-8727-50571FBFB609}"/>
              </a:ext>
            </a:extLst>
          </p:cNvPr>
          <p:cNvSpPr txBox="1"/>
          <p:nvPr/>
        </p:nvSpPr>
        <p:spPr>
          <a:xfrm>
            <a:off x="2807752" y="2599346"/>
            <a:ext cx="6226191" cy="4632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B. Parotid salivary gland of Wa </a:t>
            </a:r>
            <a:r>
              <a:rPr lang="en-US" sz="1400" b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AttHRV</a:t>
            </a: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inoculated Gn pig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1FB266F-DA2F-4CF3-AAB1-62F195225130}"/>
              </a:ext>
            </a:extLst>
          </p:cNvPr>
          <p:cNvSpPr txBox="1"/>
          <p:nvPr/>
        </p:nvSpPr>
        <p:spPr>
          <a:xfrm>
            <a:off x="2756190" y="5200167"/>
            <a:ext cx="6226191" cy="4786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. Parotid salivary gland of </a:t>
            </a:r>
            <a:r>
              <a:rPr lang="en-US" sz="1400" b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rRRV</a:t>
            </a: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inoculated Gn pig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13DCDA1-207F-4A16-B0CE-B5B2F2DC38E2}"/>
              </a:ext>
            </a:extLst>
          </p:cNvPr>
          <p:cNvSpPr txBox="1"/>
          <p:nvPr/>
        </p:nvSpPr>
        <p:spPr>
          <a:xfrm>
            <a:off x="2756190" y="7759387"/>
            <a:ext cx="3960296" cy="4103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D. Parotid salivary gland of mock inoculated Gn pigs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274FB581-A138-45BD-822F-98E1EA07FFD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6190" y="772850"/>
            <a:ext cx="1828800" cy="18288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6A5E1A4F-5A2B-4E04-B923-F9BD7B9699E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6668" y="772850"/>
            <a:ext cx="1828800" cy="18288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E4B57CC-7E72-479D-BC05-9A0E55DA1818}"/>
              </a:ext>
            </a:extLst>
          </p:cNvPr>
          <p:cNvSpPr txBox="1"/>
          <p:nvPr/>
        </p:nvSpPr>
        <p:spPr>
          <a:xfrm>
            <a:off x="4806668" y="611292"/>
            <a:ext cx="1549927" cy="561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/</a:t>
            </a:r>
            <a:r>
              <a:rPr lang="en-US" b="1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SP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324219D-814A-4B47-BB72-59156D7485EC}"/>
              </a:ext>
            </a:extLst>
          </p:cNvPr>
          <p:cNvSpPr txBox="1"/>
          <p:nvPr/>
        </p:nvSpPr>
        <p:spPr>
          <a:xfrm>
            <a:off x="2756190" y="590491"/>
            <a:ext cx="1549927" cy="561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/</a:t>
            </a:r>
            <a:r>
              <a:rPr lang="en-US" b="1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P6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77758BBD-AFAB-40C9-8C38-DF0EB952C01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6668" y="5759838"/>
            <a:ext cx="1828800" cy="18288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A70A875B-2402-401A-9A51-DC148AF0279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6190" y="5759838"/>
            <a:ext cx="1828800" cy="182880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D6950C90-1352-43CE-B367-BAB50568A105}"/>
              </a:ext>
            </a:extLst>
          </p:cNvPr>
          <p:cNvSpPr txBox="1"/>
          <p:nvPr/>
        </p:nvSpPr>
        <p:spPr>
          <a:xfrm>
            <a:off x="4806668" y="5589089"/>
            <a:ext cx="1549927" cy="561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/</a:t>
            </a:r>
            <a:r>
              <a:rPr lang="en-US" b="1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SP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5CB0E23-D991-4F6B-8367-AFA670E72AA2}"/>
              </a:ext>
            </a:extLst>
          </p:cNvPr>
          <p:cNvSpPr txBox="1"/>
          <p:nvPr/>
        </p:nvSpPr>
        <p:spPr>
          <a:xfrm>
            <a:off x="2756190" y="5568288"/>
            <a:ext cx="1549927" cy="561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/</a:t>
            </a:r>
            <a:r>
              <a:rPr lang="en-US" b="1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P6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E49F6183-CFD5-4AC7-BEB8-035AC336B79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6190" y="8372139"/>
            <a:ext cx="1828800" cy="18288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8F159BD1-4433-4DDC-8E25-F35D619B3FE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6668" y="8372139"/>
            <a:ext cx="1828800" cy="182880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67FA0FA3-AB07-49D8-83A1-FCE66E7DED3C}"/>
              </a:ext>
            </a:extLst>
          </p:cNvPr>
          <p:cNvSpPr txBox="1"/>
          <p:nvPr/>
        </p:nvSpPr>
        <p:spPr>
          <a:xfrm>
            <a:off x="4806668" y="8240782"/>
            <a:ext cx="1549927" cy="561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/</a:t>
            </a:r>
            <a:r>
              <a:rPr lang="en-US" b="1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SP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41F20EC-82E4-4994-88EB-A951EBABB5E8}"/>
              </a:ext>
            </a:extLst>
          </p:cNvPr>
          <p:cNvSpPr txBox="1"/>
          <p:nvPr/>
        </p:nvSpPr>
        <p:spPr>
          <a:xfrm>
            <a:off x="2756190" y="8219981"/>
            <a:ext cx="1549927" cy="561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/</a:t>
            </a:r>
            <a:r>
              <a:rPr lang="en-US" b="1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P6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2ADB38A9-0261-414A-B273-0676E653473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6668" y="3287564"/>
            <a:ext cx="1828800" cy="182880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F97044DE-5486-439F-BD4B-5AE89E329401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6190" y="3287564"/>
            <a:ext cx="1828800" cy="1828800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DCF2F42F-7268-4DF5-9F97-25108A5A30A9}"/>
              </a:ext>
            </a:extLst>
          </p:cNvPr>
          <p:cNvSpPr txBox="1"/>
          <p:nvPr/>
        </p:nvSpPr>
        <p:spPr>
          <a:xfrm>
            <a:off x="4806668" y="3188570"/>
            <a:ext cx="1549927" cy="561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/</a:t>
            </a:r>
            <a:r>
              <a:rPr lang="en-US" b="1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SP3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33EBE19-4698-4C64-8E3E-B1515ECB74B5}"/>
              </a:ext>
            </a:extLst>
          </p:cNvPr>
          <p:cNvSpPr txBox="1"/>
          <p:nvPr/>
        </p:nvSpPr>
        <p:spPr>
          <a:xfrm>
            <a:off x="2756190" y="3061477"/>
            <a:ext cx="1549927" cy="561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/</a:t>
            </a:r>
            <a:r>
              <a:rPr lang="en-US" b="1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P6</a:t>
            </a:r>
          </a:p>
        </p:txBody>
      </p:sp>
    </p:spTree>
    <p:extLst>
      <p:ext uri="{BB962C8B-B14F-4D97-AF65-F5344CB8AC3E}">
        <p14:creationId xmlns:p14="http://schemas.microsoft.com/office/powerpoint/2010/main" val="24962585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Picture 51">
            <a:extLst>
              <a:ext uri="{FF2B5EF4-FFF2-40B4-BE49-F238E27FC236}">
                <a16:creationId xmlns:a16="http://schemas.microsoft.com/office/drawing/2014/main" id="{8854E2FC-97A8-49F0-B962-414A8E60A8B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6260" y="739360"/>
            <a:ext cx="1828800" cy="1828800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73D70F4B-80E0-4A8F-8302-A5BE597FBA6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3173" y="720952"/>
            <a:ext cx="1828800" cy="1828800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25403635-9540-4CE6-8D22-3A46CFE7666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29904" y="689233"/>
            <a:ext cx="1828800" cy="1828800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3D288614-592C-4D52-B191-52D3A55AA7D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2451" y="3302224"/>
            <a:ext cx="1828800" cy="1828800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5C969253-6E26-4AA3-8285-BFAA0E3E86D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3173" y="3302224"/>
            <a:ext cx="1828800" cy="1828800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DE5A3E4F-EDC3-4F1D-BB5E-2EC673C4EC6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29904" y="3302224"/>
            <a:ext cx="1828800" cy="18288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2D12EBB1-E0B0-4B62-AECB-9A57B230187F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6260" y="5962178"/>
            <a:ext cx="1828800" cy="182880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13C2BD63-58E2-4B39-A659-BD2F29259E21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121" y="5970081"/>
            <a:ext cx="1828800" cy="1828800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7BB730CE-E61C-40F9-A13D-9EA2E25F4D03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29904" y="5987810"/>
            <a:ext cx="1828800" cy="18288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885F83B9-C1A5-4396-AD0D-ACB4C0BFEFED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4057" y="8513024"/>
            <a:ext cx="1828800" cy="18288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F4A9E889-709D-4CFC-82A6-50141CAE13EE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6500" y="8513327"/>
            <a:ext cx="1828800" cy="18288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E47B029E-3BC9-4353-B17E-DD2CDBE5C85B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08943" y="8513024"/>
            <a:ext cx="1828800" cy="1828800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95851048-F310-441D-B53E-99E9FEC80A4B}"/>
              </a:ext>
            </a:extLst>
          </p:cNvPr>
          <p:cNvSpPr txBox="1"/>
          <p:nvPr/>
        </p:nvSpPr>
        <p:spPr>
          <a:xfrm>
            <a:off x="2423932" y="142494"/>
            <a:ext cx="8931349" cy="4632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A. Ileum of Rotarix inoculated Gn pig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A7763EE-3EC2-49CB-A9B8-01D76E8884B7}"/>
              </a:ext>
            </a:extLst>
          </p:cNvPr>
          <p:cNvSpPr txBox="1"/>
          <p:nvPr/>
        </p:nvSpPr>
        <p:spPr>
          <a:xfrm>
            <a:off x="2329468" y="2799127"/>
            <a:ext cx="8931348" cy="4632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B. Ileum of Wa </a:t>
            </a:r>
            <a:r>
              <a:rPr lang="en-US" sz="1400" b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AttHRV</a:t>
            </a: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inoculated Gn pigs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438E7D0-2EE1-4723-8E90-909A723E9941}"/>
              </a:ext>
            </a:extLst>
          </p:cNvPr>
          <p:cNvSpPr txBox="1"/>
          <p:nvPr/>
        </p:nvSpPr>
        <p:spPr>
          <a:xfrm>
            <a:off x="2329468" y="5337862"/>
            <a:ext cx="9229060" cy="4632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. Ileum of </a:t>
            </a:r>
            <a:r>
              <a:rPr lang="en-US" sz="1400" b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rRRV</a:t>
            </a: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inoculated Gn pig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F492F59-EEF5-4083-A584-742F62F51AD2}"/>
              </a:ext>
            </a:extLst>
          </p:cNvPr>
          <p:cNvSpPr txBox="1"/>
          <p:nvPr/>
        </p:nvSpPr>
        <p:spPr>
          <a:xfrm>
            <a:off x="2423932" y="10554518"/>
            <a:ext cx="7031757" cy="17559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 S4. 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Detection of rotavirus NSP3 antigen in the ileum of  Rotarix </a:t>
            </a: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(A)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Wa </a:t>
            </a:r>
            <a:r>
              <a:rPr lang="en-US" sz="14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AttHRV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(B)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</a:t>
            </a:r>
            <a:r>
              <a:rPr lang="en-US" sz="14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rRRV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(C)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or mock </a:t>
            </a: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(D)</a:t>
            </a:r>
            <a:r>
              <a:rPr lang="en-US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inoculated pigs. Representative images from each group are shown. Images were taken using 25X objective on Zeiss LSM 880 confocal. Blue: DAPI. Green: NSP3. Scale bar is 160 pixels.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0FC70CB-ED96-439B-BEAA-D83A01454050}"/>
              </a:ext>
            </a:extLst>
          </p:cNvPr>
          <p:cNvSpPr txBox="1"/>
          <p:nvPr/>
        </p:nvSpPr>
        <p:spPr>
          <a:xfrm>
            <a:off x="2329469" y="7946190"/>
            <a:ext cx="9229059" cy="4632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D. Ileum of mock inoculated Gn pigs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2E1FEC1-CD69-4CA4-8A9C-2D1A0BBF3FF0}"/>
              </a:ext>
            </a:extLst>
          </p:cNvPr>
          <p:cNvSpPr txBox="1"/>
          <p:nvPr/>
        </p:nvSpPr>
        <p:spPr>
          <a:xfrm>
            <a:off x="2444059" y="8500305"/>
            <a:ext cx="1850910" cy="561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/</a:t>
            </a:r>
            <a:r>
              <a:rPr lang="en-US" b="1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SP3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535B34D-45A4-41FB-9AAC-DBC9B1B1B8D1}"/>
              </a:ext>
            </a:extLst>
          </p:cNvPr>
          <p:cNvSpPr txBox="1"/>
          <p:nvPr/>
        </p:nvSpPr>
        <p:spPr>
          <a:xfrm>
            <a:off x="4576500" y="8500305"/>
            <a:ext cx="1177793" cy="561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lang="en-US" b="1" dirty="0">
              <a:solidFill>
                <a:srgbClr val="00FF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08EC9CC-B61E-4422-B263-350AFE2D85DB}"/>
              </a:ext>
            </a:extLst>
          </p:cNvPr>
          <p:cNvSpPr txBox="1"/>
          <p:nvPr/>
        </p:nvSpPr>
        <p:spPr>
          <a:xfrm>
            <a:off x="6686831" y="8500305"/>
            <a:ext cx="1177793" cy="561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SP3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1F80495-71B2-4D00-A477-158D77B295EA}"/>
              </a:ext>
            </a:extLst>
          </p:cNvPr>
          <p:cNvSpPr txBox="1"/>
          <p:nvPr/>
        </p:nvSpPr>
        <p:spPr>
          <a:xfrm>
            <a:off x="2444057" y="3330579"/>
            <a:ext cx="1460475" cy="561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/</a:t>
            </a:r>
            <a:r>
              <a:rPr lang="en-US" b="1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SP3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01CD8A0-1F19-4FB0-AFAE-DF6F9CA6BFDE}"/>
              </a:ext>
            </a:extLst>
          </p:cNvPr>
          <p:cNvSpPr txBox="1"/>
          <p:nvPr/>
        </p:nvSpPr>
        <p:spPr>
          <a:xfrm>
            <a:off x="4576500" y="3330579"/>
            <a:ext cx="1177793" cy="561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lang="en-US" b="1" dirty="0">
              <a:solidFill>
                <a:srgbClr val="00FF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E15EC54-903E-4F16-B711-4E859B0DF169}"/>
              </a:ext>
            </a:extLst>
          </p:cNvPr>
          <p:cNvSpPr txBox="1"/>
          <p:nvPr/>
        </p:nvSpPr>
        <p:spPr>
          <a:xfrm>
            <a:off x="6708943" y="3330579"/>
            <a:ext cx="1177793" cy="561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SP3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866FB65-5D89-4575-9A7C-F6C88D385319}"/>
              </a:ext>
            </a:extLst>
          </p:cNvPr>
          <p:cNvSpPr txBox="1"/>
          <p:nvPr/>
        </p:nvSpPr>
        <p:spPr>
          <a:xfrm>
            <a:off x="2444058" y="6007007"/>
            <a:ext cx="1549926" cy="561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/</a:t>
            </a:r>
            <a:r>
              <a:rPr lang="en-US" b="1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SP3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639B9E4-F941-4AEC-B4E4-6785D14BD03F}"/>
              </a:ext>
            </a:extLst>
          </p:cNvPr>
          <p:cNvSpPr txBox="1"/>
          <p:nvPr/>
        </p:nvSpPr>
        <p:spPr>
          <a:xfrm>
            <a:off x="4576500" y="6007007"/>
            <a:ext cx="1177793" cy="561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lang="en-US" b="1" dirty="0">
              <a:solidFill>
                <a:srgbClr val="00FF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C1828D0-0271-452A-ACB9-915BD7C8DC04}"/>
              </a:ext>
            </a:extLst>
          </p:cNvPr>
          <p:cNvSpPr txBox="1"/>
          <p:nvPr/>
        </p:nvSpPr>
        <p:spPr>
          <a:xfrm>
            <a:off x="6708943" y="6007007"/>
            <a:ext cx="1177793" cy="561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SP3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72DAEE1-358E-4862-A162-50C2A804780F}"/>
              </a:ext>
            </a:extLst>
          </p:cNvPr>
          <p:cNvSpPr txBox="1"/>
          <p:nvPr/>
        </p:nvSpPr>
        <p:spPr>
          <a:xfrm>
            <a:off x="2444057" y="682609"/>
            <a:ext cx="1549927" cy="561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/</a:t>
            </a:r>
            <a:r>
              <a:rPr lang="en-US" b="1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SP3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4726713-0EF7-4609-BDDD-4A9742BCAB16}"/>
              </a:ext>
            </a:extLst>
          </p:cNvPr>
          <p:cNvSpPr txBox="1"/>
          <p:nvPr/>
        </p:nvSpPr>
        <p:spPr>
          <a:xfrm>
            <a:off x="4576500" y="682609"/>
            <a:ext cx="1177793" cy="561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lang="en-US" b="1" dirty="0">
              <a:solidFill>
                <a:srgbClr val="00FF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05461C1-9A83-413F-8039-930C43052230}"/>
              </a:ext>
            </a:extLst>
          </p:cNvPr>
          <p:cNvSpPr txBox="1"/>
          <p:nvPr/>
        </p:nvSpPr>
        <p:spPr>
          <a:xfrm>
            <a:off x="6708943" y="682609"/>
            <a:ext cx="1177793" cy="561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srgbClr val="00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SP3</a:t>
            </a:r>
          </a:p>
        </p:txBody>
      </p:sp>
    </p:spTree>
    <p:extLst>
      <p:ext uri="{BB962C8B-B14F-4D97-AF65-F5344CB8AC3E}">
        <p14:creationId xmlns:p14="http://schemas.microsoft.com/office/powerpoint/2010/main" val="28900281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F5841F2B68AF14E9B00CEED9DA0F07A" ma:contentTypeVersion="15" ma:contentTypeDescription="Create a new document." ma:contentTypeScope="" ma:versionID="daaece780d721c1f80af1a89ed322560">
  <xsd:schema xmlns:xsd="http://www.w3.org/2001/XMLSchema" xmlns:xs="http://www.w3.org/2001/XMLSchema" xmlns:p="http://schemas.microsoft.com/office/2006/metadata/properties" xmlns:ns3="4623f742-3371-4539-859c-9eb957f3bad7" xmlns:ns4="9ced1a48-7cac-4263-8719-dbcf375787a6" targetNamespace="http://schemas.microsoft.com/office/2006/metadata/properties" ma:root="true" ma:fieldsID="45a078d2aa5077e02efbaf6c5dafca52" ns3:_="" ns4:_="">
    <xsd:import namespace="4623f742-3371-4539-859c-9eb957f3bad7"/>
    <xsd:import namespace="9ced1a48-7cac-4263-8719-dbcf375787a6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AutoKeyPoints" minOccurs="0"/>
                <xsd:element ref="ns3:MediaServiceKeyPoints" minOccurs="0"/>
                <xsd:element ref="ns3:MediaServiceLocation" minOccurs="0"/>
                <xsd:element ref="ns3:MediaLengthInSeconds" minOccurs="0"/>
                <xsd:element ref="ns3:MediaServiceObjectDetectorVersion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623f742-3371-4539-859c-9eb957f3bad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MediaLengthInSeconds" ma:index="18" nillable="true" ma:displayName="Length (seconds)" ma:internalName="MediaLengthInSeconds" ma:readOnly="true">
      <xsd:simpleType>
        <xsd:restriction base="dms:Unknown"/>
      </xsd:simpleType>
    </xsd:element>
    <xsd:element name="MediaServiceObjectDetectorVersions" ma:index="19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ced1a48-7cac-4263-8719-dbcf375787a6" elementFormDefault="qualified">
    <xsd:import namespace="http://schemas.microsoft.com/office/2006/documentManagement/types"/>
    <xsd:import namespace="http://schemas.microsoft.com/office/infopath/2007/PartnerControls"/>
    <xsd:element name="SharedWithUsers" ma:index="2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A328EF35-B8C6-403E-AD06-57D4AA91A041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76A69050-0313-4DA0-8DFC-451002C13CE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623f742-3371-4539-859c-9eb957f3bad7"/>
    <ds:schemaRef ds:uri="9ced1a48-7cac-4263-8719-dbcf375787a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C9A54246-EFCA-4A0B-8FD2-9AB362B1F532}">
  <ds:schemaRefs>
    <ds:schemaRef ds:uri="http://purl.org/dc/terms/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http://schemas.microsoft.com/office/2006/documentManagement/types"/>
    <ds:schemaRef ds:uri="http://purl.org/dc/elements/1.1/"/>
    <ds:schemaRef ds:uri="http://schemas.microsoft.com/office/2006/metadata/properties"/>
    <ds:schemaRef ds:uri="9ced1a48-7cac-4263-8719-dbcf375787a6"/>
    <ds:schemaRef ds:uri="4623f742-3371-4539-859c-9eb957f3bad7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66</TotalTime>
  <Words>859</Words>
  <Application>Microsoft Office PowerPoint</Application>
  <PresentationFormat>Custom</PresentationFormat>
  <Paragraphs>251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3" baseType="lpstr">
      <vt:lpstr>Arial</vt:lpstr>
      <vt:lpstr>Calibri</vt:lpstr>
      <vt:lpstr>Calibri Light</vt:lpstr>
      <vt:lpstr>Palatino Linotype</vt:lpstr>
      <vt:lpstr>Times New Roman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yblade, Charlotte</dc:creator>
  <cp:lastModifiedBy>MDPI</cp:lastModifiedBy>
  <cp:revision>135</cp:revision>
  <dcterms:created xsi:type="dcterms:W3CDTF">2022-12-16T18:07:45Z</dcterms:created>
  <dcterms:modified xsi:type="dcterms:W3CDTF">2023-08-31T21:17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F5841F2B68AF14E9B00CEED9DA0F07A</vt:lpwstr>
  </property>
</Properties>
</file>